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7474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348" autoAdjust="0"/>
    <p:restoredTop sz="89463" autoAdjust="0"/>
  </p:normalViewPr>
  <p:slideViewPr>
    <p:cSldViewPr snapToGrid="0">
      <p:cViewPr varScale="1">
        <p:scale>
          <a:sx n="101" d="100"/>
          <a:sy n="101" d="100"/>
        </p:scale>
        <p:origin x="24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20127F-E7C3-499D-87D0-FB73F73DE973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294EE7-32C3-4A76-8BAA-0F2EFB63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78075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002AA2-643D-396E-9897-37C82F313E3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A9E1D41-D2BC-58BA-9552-052D909D247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034468-C373-0A43-9265-6F8C1B00AB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16B628-2923-9B51-14BA-6DEA6BD3B4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8C64F0-1363-F03D-CBAB-818066C5CA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55578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9B78FD-C4C3-28FE-E46B-78476FD269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4B73FEB-EE35-AEB8-6D45-8F130690AF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BFEA45-A444-4626-0891-E74ECF429C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128966-8990-E71C-3593-36941573C7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348F2B-BE74-F041-8A76-7A0E763370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2644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1FE38DD-2BF9-5829-B68A-7CC440475F8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624E60-D797-800A-77DB-D9807ECCB9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59B996-3A4D-B2AC-3064-92F2731120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887AA3-7C6E-3C97-ABEA-45BB846476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DB0BC9-E2FF-C1B2-BB04-8C19F543B9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4278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05ACD5-8F36-3716-24A9-D54619B0CF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581EB4-D1F8-1058-FC68-0F0E722B3A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CF9399-6487-51B8-34C7-7F0E058867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6A8CC8-5E39-10EF-D6F1-09FA6C873E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596D50-0841-FC4E-3B1D-D55644A373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8257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BAA356-40EF-EA35-359D-E32B9FF174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8BBB6F3-408B-77CB-EF30-8DCF4AE30D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CE6F1D-8B90-16B0-E6B3-9A4ED102B2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49C4A7-C8EC-E372-4C3D-DDF6FCA663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854AE6-DBB7-9C65-F12D-9A57990CC6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8829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FDD54F-CEE3-536E-3B37-20ED3B0BCD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A5AB7BF-3839-E576-CAC5-F5D9BC958C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D5AF6FA-FE95-D6BD-DF62-AB12A95101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657D9D-359E-8F69-394B-86D0C87DE4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ABD2B5-1FC5-B07D-E4A0-84611E81AA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CD874A-5497-961F-41D7-7663A6B861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92132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153C7E-E3F0-0B45-EA3E-1CD11DABE0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34BEB3-2FA7-66C4-EBC3-4F2C23B91E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5E56D9-4B77-3B15-F4CB-155318B382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BACC024-FEAE-CA44-D686-C063CBF412F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571FAC7-4E9D-7F6A-A1DA-F14277AB64D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F5F4EF4-97A4-E80E-E4BB-B72EDC077D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670EA3A-014B-546D-BAE3-D5B34C5707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211DA68-99C5-BF6E-00C0-CD343979AE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0876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8F4C40-0ED6-5CB5-8F20-705F6D2D42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DEE02FC-6A96-4DCA-16A8-5DEB619E8E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555BA05-66F1-919B-2032-324CCACF95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FF13DDD-4F58-E5EA-2462-0BE72E4AD0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80747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11181DE-CC5E-414E-6778-C5923DBB62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AB9BF87-E610-89BC-5EFA-C9351F2E14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75B81EF-13B2-041D-3E16-EC54DF7F4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3529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8A4330-DF86-604D-A4BA-E3AADFC52D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DAD60F-AD60-49D8-02F3-4A99E87594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CDF7D71-6BA7-768A-0BA9-E05350857E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9F720B-1E30-2A62-9360-788E0B98D7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3A0F762-8EB7-3CFE-99D8-7F8F490A9C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9656EAF-17D3-D0C7-D098-6E3C11FBD6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38275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C9FE45-8DAC-E665-9AD2-969DCEBDB3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2A70F62-E3A8-ED31-3A2F-361909DFF6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F2B8889-C7D0-E4BD-6246-53D00C70FD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66F377-A668-0E56-4D49-768B4C27E5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B495D8-C24E-6905-DCF2-8D98AE85F4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6D1483-02C0-5771-1DCE-C7900E2506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2778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95F7B11-ACF7-F065-A8C9-497B07D0E5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04D26F-3D44-ED5E-5930-6C46B358D4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CAAC75-30B3-8555-5B11-3EBAC0BF3FD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AD1939-41DC-616A-23E0-70D1E46F687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BD8A46-AAA6-9F36-1323-CBCBB22CC8F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7083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EB681FF-B227-EA41-678A-D8DB99275C1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25062" y="195759"/>
            <a:ext cx="5093237" cy="331497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9AB6BBA-D4BE-0CC3-A955-F05EE9EC5E47}"/>
              </a:ext>
            </a:extLst>
          </p:cNvPr>
          <p:cNvSpPr txBox="1"/>
          <p:nvPr/>
        </p:nvSpPr>
        <p:spPr>
          <a:xfrm>
            <a:off x="776532" y="195759"/>
            <a:ext cx="32430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A. C1D1 vs PBMC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B2C52640-2489-B2E8-A8F6-F48F684C2F7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25062" y="3510733"/>
            <a:ext cx="5093237" cy="338702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8228207F-DFDC-3A15-5E46-10041839B156}"/>
              </a:ext>
            </a:extLst>
          </p:cNvPr>
          <p:cNvSpPr txBox="1"/>
          <p:nvPr/>
        </p:nvSpPr>
        <p:spPr>
          <a:xfrm>
            <a:off x="776532" y="3469590"/>
            <a:ext cx="2153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. C2D5 vs PBMC      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03E2BD1-0E48-C4C3-8D69-66BE58F524A7}"/>
              </a:ext>
            </a:extLst>
          </p:cNvPr>
          <p:cNvSpPr txBox="1"/>
          <p:nvPr/>
        </p:nvSpPr>
        <p:spPr>
          <a:xfrm>
            <a:off x="7416800" y="565091"/>
            <a:ext cx="4165600" cy="477053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3: Genomic distribution of hypomethylated DMPs in patient PBMCs compared to normal controls. 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Pie charts of hypomethylated DMPs by CpG island (CGI) position (left panels) and relation to gene category (right panels) for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).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cycle 1 day 1 (C1D1; pre-treatment) vs. normal PBMCs and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).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cycle 2 day 5 (C2D5; post-treatment) vs. normal PBMCs. CGI positions include Open Sea (&gt;4 kb from CpG island), Shore (0-2 kb from island), Shelf (2-4 kb from island), and Island regions. Gene categories include intergenic regions, gene body, 5'UTR, TSS1500 (200-1500 bp upstream of transcription start site), TSS200 (0-200 bp upstream of TSS), and 1st exon. DMPs were identified using significance thresholds of p &lt; 0.05 and |</a:t>
            </a:r>
            <a:r>
              <a:rPr lang="el-GR" sz="1600" dirty="0">
                <a:latin typeface="Arial" panose="020B0604020202020204" pitchFamily="34" charset="0"/>
                <a:cs typeface="Arial" panose="020B0604020202020204" pitchFamily="34" charset="0"/>
              </a:rPr>
              <a:t>β| &gt; 20%. 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841651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99</TotalTime>
  <Words>165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basi Farid, Elnaz</dc:creator>
  <cp:lastModifiedBy>MDPI</cp:lastModifiedBy>
  <cp:revision>102</cp:revision>
  <cp:lastPrinted>2025-11-20T14:34:39Z</cp:lastPrinted>
  <dcterms:created xsi:type="dcterms:W3CDTF">2025-04-15T14:41:30Z</dcterms:created>
  <dcterms:modified xsi:type="dcterms:W3CDTF">2026-03-26T07:42:37Z</dcterms:modified>
</cp:coreProperties>
</file>